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tif" ContentType="image/tif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FECF9B-A3F9-46B2-A55C-E7C38C8BAA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21C71-C6E9-4A54-9591-5416F36F5E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36016-DC4D-455D-9AB4-D819BB48A5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50604-CAD6-4E9F-AD3D-F759B86FBB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53656-7455-4A20-9311-1076B68E41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1D203-2945-41C7-96BA-608413EA3C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D4A9B-A2E8-4140-AB1D-79FF2C8A0C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B10F8-8E56-43D3-AB1E-28AA36A1DD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DF3D4-C4B5-4CC2-AD77-E83B910A90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E2FD2-7F34-4544-AD5E-01D98CBCB0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02769-3279-4159-90B9-92F3F76808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5F22F-4899-4884-81DF-84D16C92B2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914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371600" indent="-45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28800" indent="-914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FF2CFA-9771-448F-9477-9AD32FA34F6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ti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143000" y="1122480"/>
            <a:ext cx="7167600" cy="238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zh-CN" sz="32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zh-CN" sz="3200" spc="-1" strike="noStrike">
                <a:solidFill>
                  <a:srgbClr val="000000"/>
                </a:solidFill>
                <a:latin typeface="Arial"/>
              </a:rPr>
              <a:t>-Demethylsinomenine, an active metabolite of sinomenine, attenuates chronic neuropathic and inflammatory pain in mice</a:t>
            </a:r>
            <a:br>
              <a:rPr sz="4500"/>
            </a:b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1143000" y="3601800"/>
            <a:ext cx="7169040" cy="165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Zhiyong Zhou</a:t>
            </a:r>
            <a:r>
              <a:rPr b="0" lang="zh-CN" sz="1800" spc="-1" strike="noStrike" baseline="30000">
                <a:solidFill>
                  <a:srgbClr val="000000"/>
                </a:solidFill>
                <a:latin typeface="Arial"/>
              </a:rPr>
              <a:t>†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, Nanqing Qiu</a:t>
            </a:r>
            <a:r>
              <a:rPr b="0" lang="zh-CN" sz="1800" spc="-1" strike="noStrike" baseline="30000">
                <a:solidFill>
                  <a:srgbClr val="000000"/>
                </a:solidFill>
                <a:latin typeface="Arial"/>
              </a:rPr>
              <a:t>†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, Yuntao Ou</a:t>
            </a:r>
            <a:r>
              <a:rPr b="0" lang="zh-CN" sz="1800" spc="-1" strike="noStrike" baseline="30000">
                <a:solidFill>
                  <a:srgbClr val="000000"/>
                </a:solidFill>
                <a:latin typeface="Arial"/>
              </a:rPr>
              <a:t>†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, Qianqian Wei, Wenting Tang, Mingcong Zheng, Yaluan Xing, Jie-Jia Li, Yong Ling, Junxu Li* and Qing Zhu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99"/>
          <p:cNvSpPr/>
          <p:nvPr/>
        </p:nvSpPr>
        <p:spPr>
          <a:xfrm>
            <a:off x="917640" y="4451400"/>
            <a:ext cx="70261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1. The mechanical allodynia induced by CCI surgery (left) and CFA injection (right) in mice. Ordinates: paw withdrawal threshold (g) measured by von Frey filament; Abscissa: days after CCI surgery or CFA injection. BL:baseline value prior to CCI suegery or CFA injection; Filled symbols indicate statistical differences with paired control group as analyzed by two-way ANOVA with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post hoc Bonferroni’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analysis (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P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&lt;0.001, n=7-8 per group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图片 1" descr=""/>
          <p:cNvPicPr/>
          <p:nvPr/>
        </p:nvPicPr>
        <p:blipFill>
          <a:blip r:embed="rId1"/>
          <a:stretch/>
        </p:blipFill>
        <p:spPr>
          <a:xfrm>
            <a:off x="428760" y="1109520"/>
            <a:ext cx="8002440" cy="290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3"/>
          <p:cNvSpPr/>
          <p:nvPr/>
        </p:nvSpPr>
        <p:spPr>
          <a:xfrm>
            <a:off x="892080" y="4552920"/>
            <a:ext cx="762660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2. Selected doses (10-40 mg/kg) of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 N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-demethylsinomenine and sinomenine both have no suppression on spontaneous locomotor activity in healthy mice. Data were presented as mean±SEM. “ns” indicated no significant difference as compared to vehicle control (P&gt;0.05) as analyzed by one-way ANOVA with Bonferroni’s post hoc analysis (n=8 per group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图片 5" descr="Figure 2"/>
          <p:cNvPicPr/>
          <p:nvPr/>
        </p:nvPicPr>
        <p:blipFill>
          <a:blip r:embed="rId1"/>
          <a:stretch/>
        </p:blipFill>
        <p:spPr>
          <a:xfrm>
            <a:off x="2027160" y="633240"/>
            <a:ext cx="4788000" cy="3640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99"/>
          <p:cNvSpPr/>
          <p:nvPr/>
        </p:nvSpPr>
        <p:spPr>
          <a:xfrm>
            <a:off x="1049400" y="4424400"/>
            <a:ext cx="686412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3. Neither the opioid receptor antagonist naltrexone nor the 5-HT1A receptor antagonist WAY100635 blocked the anti-allodynic effects of 40 mg/kg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N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-demethylsinomenine in CCI mice. Data were expressed mean±S.E.M and analyzed by two-way ANOVA with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</a:rPr>
              <a:t>post hoc Bonferroni’s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 analysis (n=6 per group)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图片 3" descr=""/>
          <p:cNvPicPr/>
          <p:nvPr/>
        </p:nvPicPr>
        <p:blipFill>
          <a:blip r:embed="rId1"/>
          <a:stretch/>
        </p:blipFill>
        <p:spPr>
          <a:xfrm>
            <a:off x="1846440" y="542880"/>
            <a:ext cx="4478040" cy="377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1-11T23:37:27Z</dcterms:created>
  <dc:creator>admin</dc:creator>
  <dc:description/>
  <dc:language>en-US</dc:language>
  <cp:lastModifiedBy>Jukin</cp:lastModifiedBy>
  <dcterms:modified xsi:type="dcterms:W3CDTF">2021-01-26T16:10:35Z</dcterms:modified>
  <cp:revision>6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